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4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10" d="100"/>
          <a:sy n="110" d="100"/>
        </p:scale>
        <p:origin x="-481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4D2EDEEA-FA46-4FCC-B660-1ED59E6AF29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F128-4463-818B-7747613D69C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82571336-23E7-4A69-B04A-ED9EB9094A0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F128-4463-818B-7747613D69C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127BF756-3294-4C29-AEC3-4FF828AEF54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F128-4463-818B-7747613D69C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A556C1F3-971B-4412-93B7-84A8F9AC74A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F128-4463-818B-7747613D69C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63C90D04-304D-4C1C-9DBD-5EE2580B335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F128-4463-818B-7747613D69C4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FB8633BC-8224-4409-8902-3630F4CA5C2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F128-4463-818B-7747613D69C4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671A018C-60B4-4471-BF32-E46EBBD5B73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F128-4463-818B-7747613D69C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F090012B-8942-4C0C-AC84-D1CBD88BBEE0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F128-4463-818B-7747613D69C4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81475545-A67F-40AA-A249-1A94FE8ED727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F128-4463-818B-7747613D69C4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E30B29C0-EF4A-4EDC-B737-A9982DA848B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F128-4463-818B-7747613D69C4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9695C3EA-06F6-48BA-8D2C-9BB782E1A6E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F128-4463-818B-7747613D69C4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0B514DCB-9E23-427A-9FA5-6E7B89C4001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F128-4463-818B-7747613D69C4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88BCD8BB-F5BB-4EBE-B621-45D5C46A3AB0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C-F128-4463-818B-7747613D69C4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DCC6A62F-E6B3-4280-94F8-3EAB0DC00A2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D-F128-4463-818B-7747613D69C4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93EF7142-448E-4539-B968-78708A91FF55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E-F128-4463-818B-7747613D69C4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5F692D4A-9AB2-476F-A582-B5B0CEE39C4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F-F128-4463-818B-7747613D69C4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3C81C451-BE55-46CB-9E70-2D8CBBC5B8B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0-F128-4463-818B-7747613D69C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numRef>
              <c:f>Sheet10!$C$81:$C$9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</c:numCache>
            </c:numRef>
          </c:cat>
          <c:val>
            <c:numRef>
              <c:f>Sheet10!$E$81:$E$97</c:f>
              <c:numCache>
                <c:formatCode>General</c:formatCode>
                <c:ptCount val="17"/>
                <c:pt idx="0">
                  <c:v>13.24</c:v>
                </c:pt>
                <c:pt idx="1">
                  <c:v>16.34</c:v>
                </c:pt>
                <c:pt idx="2">
                  <c:v>11.55</c:v>
                </c:pt>
                <c:pt idx="3">
                  <c:v>11.83</c:v>
                </c:pt>
                <c:pt idx="4">
                  <c:v>12.39</c:v>
                </c:pt>
                <c:pt idx="5">
                  <c:v>5.92</c:v>
                </c:pt>
                <c:pt idx="6">
                  <c:v>7.32</c:v>
                </c:pt>
                <c:pt idx="7">
                  <c:v>5.35</c:v>
                </c:pt>
                <c:pt idx="8">
                  <c:v>3.38</c:v>
                </c:pt>
                <c:pt idx="9">
                  <c:v>4.51</c:v>
                </c:pt>
                <c:pt idx="10">
                  <c:v>1.97</c:v>
                </c:pt>
                <c:pt idx="11">
                  <c:v>1.69</c:v>
                </c:pt>
                <c:pt idx="12">
                  <c:v>0.85</c:v>
                </c:pt>
                <c:pt idx="13">
                  <c:v>1.97</c:v>
                </c:pt>
                <c:pt idx="14">
                  <c:v>1.1299999999999999</c:v>
                </c:pt>
                <c:pt idx="15">
                  <c:v>0.28000000000000003</c:v>
                </c:pt>
                <c:pt idx="16">
                  <c:v>0.28000000000000003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Sheet10!$D$81:$D$97</c15:f>
                <c15:dlblRangeCache>
                  <c:ptCount val="17"/>
                  <c:pt idx="0">
                    <c:v>47</c:v>
                  </c:pt>
                  <c:pt idx="1">
                    <c:v>58</c:v>
                  </c:pt>
                  <c:pt idx="2">
                    <c:v>41</c:v>
                  </c:pt>
                  <c:pt idx="3">
                    <c:v>42</c:v>
                  </c:pt>
                  <c:pt idx="4">
                    <c:v>44</c:v>
                  </c:pt>
                  <c:pt idx="5">
                    <c:v>21</c:v>
                  </c:pt>
                  <c:pt idx="6">
                    <c:v>26</c:v>
                  </c:pt>
                  <c:pt idx="7">
                    <c:v>19</c:v>
                  </c:pt>
                  <c:pt idx="8">
                    <c:v>12</c:v>
                  </c:pt>
                  <c:pt idx="9">
                    <c:v>16</c:v>
                  </c:pt>
                  <c:pt idx="10">
                    <c:v>7</c:v>
                  </c:pt>
                  <c:pt idx="11">
                    <c:v>6</c:v>
                  </c:pt>
                  <c:pt idx="12">
                    <c:v>3</c:v>
                  </c:pt>
                  <c:pt idx="13">
                    <c:v>7</c:v>
                  </c:pt>
                  <c:pt idx="14">
                    <c:v>4</c:v>
                  </c:pt>
                  <c:pt idx="15">
                    <c:v>1</c:v>
                  </c:pt>
                  <c:pt idx="16">
                    <c:v>1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1-F128-4463-818B-7747613D69C4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395985416"/>
        <c:axId val="395980168"/>
      </c:barChart>
      <c:catAx>
        <c:axId val="395985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 of conditions endorse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980168"/>
        <c:crosses val="autoZero"/>
        <c:auto val="1"/>
        <c:lblAlgn val="ctr"/>
        <c:lblOffset val="100"/>
        <c:noMultiLvlLbl val="0"/>
      </c:catAx>
      <c:valAx>
        <c:axId val="3959801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ercent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985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215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748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708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320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346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07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246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744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728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80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322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73C42-3098-47CC-AFA7-BD359E5915A4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756B3-5680-4C81-B2C7-B173C3E7F1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532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642890" y="4359909"/>
            <a:ext cx="2268365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FXPOI with mental health conditions</a:t>
            </a:r>
            <a:endParaRPr lang="en-US" sz="1100" dirty="0"/>
          </a:p>
        </p:txBody>
      </p:sp>
      <p:grpSp>
        <p:nvGrpSpPr>
          <p:cNvPr id="3" name="Group 2"/>
          <p:cNvGrpSpPr/>
          <p:nvPr/>
        </p:nvGrpSpPr>
        <p:grpSpPr>
          <a:xfrm>
            <a:off x="7765165" y="383069"/>
            <a:ext cx="1938328" cy="5596398"/>
            <a:chOff x="4995322" y="617792"/>
            <a:chExt cx="2323033" cy="5453161"/>
          </a:xfrm>
        </p:grpSpPr>
        <p:sp>
          <p:nvSpPr>
            <p:cNvPr id="4" name="TextBox 3"/>
            <p:cNvSpPr txBox="1"/>
            <p:nvPr/>
          </p:nvSpPr>
          <p:spPr>
            <a:xfrm>
              <a:off x="5322768" y="1378171"/>
              <a:ext cx="1588964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Minimal conditions</a:t>
              </a:r>
              <a:endParaRPr lang="en-US" sz="11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605376" y="2028219"/>
              <a:ext cx="102374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Headaches</a:t>
              </a:r>
              <a:endParaRPr lang="en-US" sz="11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16957" y="2652938"/>
              <a:ext cx="2000588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Mental health conditions</a:t>
              </a:r>
              <a:endParaRPr lang="en-US" sz="11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25673" y="3297598"/>
              <a:ext cx="1383157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Sleep problems</a:t>
              </a:r>
              <a:endParaRPr lang="en-US" sz="11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95322" y="3832698"/>
              <a:ext cx="2323033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 with minimal conditions</a:t>
              </a:r>
              <a:endParaRPr lang="en-US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12275" y="5153882"/>
              <a:ext cx="1330191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: complex</a:t>
              </a:r>
              <a:endParaRPr lang="en-US" sz="11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919095" y="5809343"/>
              <a:ext cx="71655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TAS</a:t>
              </a:r>
              <a:endParaRPr lang="en-US" sz="11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261044" y="617792"/>
              <a:ext cx="1712411" cy="419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u="sng" dirty="0" smtClean="0"/>
                <a:t>8-cluster </a:t>
              </a:r>
              <a:r>
                <a:rPr lang="en-US" sz="1100" b="1" u="sng" dirty="0" smtClean="0"/>
                <a:t>model</a:t>
              </a:r>
            </a:p>
            <a:p>
              <a:pPr algn="ctr"/>
              <a:r>
                <a:rPr lang="en-US" sz="1100" b="1" dirty="0" smtClean="0"/>
                <a:t>R</a:t>
              </a:r>
              <a:r>
                <a:rPr lang="en-US" sz="1100" b="1" baseline="30000" dirty="0" smtClean="0"/>
                <a:t>2</a:t>
              </a:r>
              <a:r>
                <a:rPr lang="en-US" sz="1100" b="1" dirty="0" smtClean="0"/>
                <a:t>=0.310</a:t>
              </a:r>
              <a:endParaRPr lang="en-US" sz="1100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9579216" y="365789"/>
            <a:ext cx="17124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u="sng" dirty="0"/>
              <a:t>9</a:t>
            </a:r>
            <a:r>
              <a:rPr lang="en-US" sz="1100" b="1" u="sng" dirty="0" smtClean="0"/>
              <a:t>-cluster </a:t>
            </a:r>
            <a:r>
              <a:rPr lang="en-US" sz="1100" b="1" u="sng" dirty="0" smtClean="0"/>
              <a:t>model</a:t>
            </a:r>
          </a:p>
          <a:p>
            <a:pPr algn="ctr"/>
            <a:r>
              <a:rPr lang="en-US" sz="1100" b="1" dirty="0" smtClean="0"/>
              <a:t>R</a:t>
            </a:r>
            <a:r>
              <a:rPr lang="en-US" sz="1100" b="1" baseline="30000" dirty="0" smtClean="0"/>
              <a:t>2</a:t>
            </a:r>
            <a:r>
              <a:rPr lang="en-US" sz="1100" b="1" dirty="0" smtClean="0"/>
              <a:t>=0.327</a:t>
            </a:r>
            <a:endParaRPr 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1070947" y="365789"/>
            <a:ext cx="12156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u="sng" dirty="0" smtClean="0"/>
              <a:t>10-cluster </a:t>
            </a:r>
            <a:r>
              <a:rPr lang="en-US" sz="1100" b="1" u="sng" dirty="0" smtClean="0"/>
              <a:t>model</a:t>
            </a:r>
          </a:p>
          <a:p>
            <a:pPr algn="ctr"/>
            <a:r>
              <a:rPr lang="en-US" sz="1100" b="1" dirty="0" smtClean="0"/>
              <a:t>R</a:t>
            </a:r>
            <a:r>
              <a:rPr lang="en-US" sz="1100" b="1" baseline="30000" dirty="0" smtClean="0"/>
              <a:t>2</a:t>
            </a:r>
            <a:r>
              <a:rPr lang="en-US" sz="1100" b="1" dirty="0" smtClean="0"/>
              <a:t>=0.341</a:t>
            </a:r>
            <a:endParaRPr lang="en-US" sz="1100" b="1" dirty="0"/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9691631" y="3646223"/>
            <a:ext cx="431842" cy="1580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stCxn id="8" idx="3"/>
          </p:cNvCxnSpPr>
          <p:nvPr/>
        </p:nvCxnSpPr>
        <p:spPr>
          <a:xfrm>
            <a:off x="9703493" y="3816661"/>
            <a:ext cx="419980" cy="185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9" idx="3"/>
          </p:cNvCxnSpPr>
          <p:nvPr/>
        </p:nvCxnSpPr>
        <p:spPr>
          <a:xfrm flipV="1">
            <a:off x="9911255" y="4359434"/>
            <a:ext cx="1536065" cy="1312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9" idx="3"/>
          </p:cNvCxnSpPr>
          <p:nvPr/>
        </p:nvCxnSpPr>
        <p:spPr>
          <a:xfrm>
            <a:off x="9911255" y="4490714"/>
            <a:ext cx="1549326" cy="4545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0166751" y="3493569"/>
            <a:ext cx="655717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A: N=27</a:t>
            </a:r>
            <a:endParaRPr lang="en-US" sz="1100" dirty="0"/>
          </a:p>
        </p:txBody>
      </p:sp>
      <p:sp>
        <p:nvSpPr>
          <p:cNvPr id="37" name="TextBox 36"/>
          <p:cNvSpPr txBox="1"/>
          <p:nvPr/>
        </p:nvSpPr>
        <p:spPr>
          <a:xfrm>
            <a:off x="10166751" y="3887718"/>
            <a:ext cx="655717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B</a:t>
            </a:r>
            <a:r>
              <a:rPr lang="en-US" sz="1100" dirty="0" smtClean="0"/>
              <a:t>: N=40</a:t>
            </a:r>
            <a:endParaRPr lang="en-US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11460581" y="4783965"/>
            <a:ext cx="655221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B</a:t>
            </a:r>
            <a:r>
              <a:rPr lang="en-US" sz="1100" dirty="0" smtClean="0"/>
              <a:t>: N=22</a:t>
            </a:r>
            <a:endParaRPr lang="en-US" sz="1100" dirty="0"/>
          </a:p>
        </p:txBody>
      </p:sp>
      <p:sp>
        <p:nvSpPr>
          <p:cNvPr id="39" name="TextBox 38"/>
          <p:cNvSpPr txBox="1"/>
          <p:nvPr/>
        </p:nvSpPr>
        <p:spPr>
          <a:xfrm>
            <a:off x="11447320" y="4229104"/>
            <a:ext cx="66848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A: N=24</a:t>
            </a:r>
            <a:endParaRPr lang="en-US" sz="1100" dirty="0"/>
          </a:p>
        </p:txBody>
      </p:sp>
      <p:grpSp>
        <p:nvGrpSpPr>
          <p:cNvPr id="25" name="Group 24"/>
          <p:cNvGrpSpPr/>
          <p:nvPr/>
        </p:nvGrpSpPr>
        <p:grpSpPr>
          <a:xfrm>
            <a:off x="5150068" y="365789"/>
            <a:ext cx="2253265" cy="4930699"/>
            <a:chOff x="3740079" y="453450"/>
            <a:chExt cx="2253265" cy="4930699"/>
          </a:xfrm>
        </p:grpSpPr>
        <p:sp>
          <p:nvSpPr>
            <p:cNvPr id="40" name="TextBox 39"/>
            <p:cNvSpPr txBox="1"/>
            <p:nvPr/>
          </p:nvSpPr>
          <p:spPr>
            <a:xfrm>
              <a:off x="3924069" y="453450"/>
              <a:ext cx="149904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u="sng" dirty="0"/>
                <a:t>7</a:t>
              </a:r>
              <a:r>
                <a:rPr lang="en-US" sz="1100" b="1" u="sng" dirty="0" smtClean="0"/>
                <a:t>-cluster </a:t>
              </a:r>
              <a:r>
                <a:rPr lang="en-US" sz="1100" b="1" u="sng" dirty="0" smtClean="0"/>
                <a:t>model</a:t>
              </a:r>
            </a:p>
            <a:p>
              <a:pPr algn="ctr"/>
              <a:r>
                <a:rPr lang="en-US" sz="1100" b="1" dirty="0" smtClean="0"/>
                <a:t>R</a:t>
              </a:r>
              <a:r>
                <a:rPr lang="en-US" sz="1100" b="1" baseline="30000" dirty="0" smtClean="0"/>
                <a:t>2</a:t>
              </a:r>
              <a:r>
                <a:rPr lang="en-US" sz="1100" b="1" dirty="0" smtClean="0"/>
                <a:t>=0.292</a:t>
              </a:r>
              <a:endParaRPr lang="en-US" sz="11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987096" y="1284189"/>
              <a:ext cx="139097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Minimal conditions</a:t>
              </a:r>
              <a:endParaRPr lang="en-US" sz="11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234490" y="1945724"/>
              <a:ext cx="89619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Headaches</a:t>
              </a:r>
              <a:endParaRPr lang="en-US" sz="11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924069" y="2569286"/>
              <a:ext cx="1751315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Mental health conditions</a:t>
              </a:r>
              <a:endParaRPr lang="en-US" sz="11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022033" y="3203616"/>
              <a:ext cx="163573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Sleep problems / FXTA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848654" y="3823460"/>
              <a:ext cx="1929042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 with minimal conditions</a:t>
              </a:r>
              <a:endParaRPr lang="en-US" sz="11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740079" y="4423882"/>
              <a:ext cx="2253265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 with mental health conditions</a:t>
              </a:r>
              <a:endParaRPr lang="en-US" sz="11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100364" y="5122539"/>
              <a:ext cx="116444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: complex</a:t>
              </a:r>
              <a:endParaRPr lang="en-US" sz="1100" dirty="0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9782142" y="6387893"/>
            <a:ext cx="28048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Supplementary Figure 1</a:t>
            </a:r>
            <a:endParaRPr lang="en-US" sz="1100" dirty="0"/>
          </a:p>
        </p:txBody>
      </p:sp>
      <p:grpSp>
        <p:nvGrpSpPr>
          <p:cNvPr id="26" name="Group 25"/>
          <p:cNvGrpSpPr/>
          <p:nvPr/>
        </p:nvGrpSpPr>
        <p:grpSpPr>
          <a:xfrm>
            <a:off x="2584127" y="383069"/>
            <a:ext cx="2377295" cy="4930699"/>
            <a:chOff x="639774" y="453450"/>
            <a:chExt cx="2377295" cy="4930699"/>
          </a:xfrm>
        </p:grpSpPr>
        <p:sp>
          <p:nvSpPr>
            <p:cNvPr id="49" name="TextBox 48"/>
            <p:cNvSpPr txBox="1"/>
            <p:nvPr/>
          </p:nvSpPr>
          <p:spPr>
            <a:xfrm>
              <a:off x="1069906" y="453450"/>
              <a:ext cx="149904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u="sng" dirty="0" smtClean="0"/>
                <a:t>6-cluster </a:t>
              </a:r>
              <a:r>
                <a:rPr lang="en-US" sz="1100" b="1" u="sng" dirty="0" smtClean="0"/>
                <a:t>model</a:t>
              </a:r>
            </a:p>
            <a:p>
              <a:pPr algn="ctr"/>
              <a:r>
                <a:rPr lang="en-US" sz="1100" b="1" dirty="0" smtClean="0"/>
                <a:t>R</a:t>
              </a:r>
              <a:r>
                <a:rPr lang="en-US" sz="1100" b="1" baseline="30000" dirty="0" smtClean="0"/>
                <a:t>2</a:t>
              </a:r>
              <a:r>
                <a:rPr lang="en-US" sz="1100" b="1" dirty="0" smtClean="0"/>
                <a:t>=0.271</a:t>
              </a:r>
              <a:endParaRPr lang="en-US" sz="1100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132933" y="1284189"/>
              <a:ext cx="139097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Minimal conditions</a:t>
              </a:r>
              <a:endParaRPr lang="en-US" sz="11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380328" y="1934237"/>
              <a:ext cx="89619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Headaches</a:t>
              </a:r>
              <a:endParaRPr lang="en-US" sz="11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037571" y="3232618"/>
              <a:ext cx="153138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Sleep problems/ FXTA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870439" y="3795616"/>
              <a:ext cx="1915963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 with minimal conditions</a:t>
              </a:r>
              <a:endParaRPr lang="en-US" sz="11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39774" y="4406602"/>
              <a:ext cx="2377295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FXPOI with mental health conditions / Mental Health condition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246201" y="5122539"/>
              <a:ext cx="116444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: complex</a:t>
              </a:r>
              <a:endParaRPr lang="en-US" sz="1100" dirty="0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83571" y="389028"/>
            <a:ext cx="2377295" cy="4930699"/>
            <a:chOff x="639774" y="453450"/>
            <a:chExt cx="2377295" cy="4930699"/>
          </a:xfrm>
        </p:grpSpPr>
        <p:sp>
          <p:nvSpPr>
            <p:cNvPr id="61" name="TextBox 60"/>
            <p:cNvSpPr txBox="1"/>
            <p:nvPr/>
          </p:nvSpPr>
          <p:spPr>
            <a:xfrm>
              <a:off x="1069906" y="453450"/>
              <a:ext cx="149904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u="sng" dirty="0"/>
                <a:t>5</a:t>
              </a:r>
              <a:r>
                <a:rPr lang="en-US" sz="1100" b="1" u="sng" dirty="0" smtClean="0"/>
                <a:t>-cluster </a:t>
              </a:r>
              <a:r>
                <a:rPr lang="en-US" sz="1100" b="1" u="sng" dirty="0" smtClean="0"/>
                <a:t>model</a:t>
              </a:r>
            </a:p>
            <a:p>
              <a:pPr algn="ctr"/>
              <a:r>
                <a:rPr lang="en-US" sz="1100" b="1" dirty="0" smtClean="0"/>
                <a:t>R</a:t>
              </a:r>
              <a:r>
                <a:rPr lang="en-US" sz="1100" b="1" baseline="30000" dirty="0" smtClean="0"/>
                <a:t>2</a:t>
              </a:r>
              <a:r>
                <a:rPr lang="en-US" sz="1100" b="1" dirty="0" smtClean="0"/>
                <a:t>=0.244</a:t>
              </a:r>
              <a:endParaRPr lang="en-US" sz="1100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80328" y="1934237"/>
              <a:ext cx="89619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Headaches</a:t>
              </a:r>
              <a:endParaRPr lang="en-US" sz="11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037571" y="3232618"/>
              <a:ext cx="1531380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Sleep problems/ FXTA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64699" y="3833723"/>
              <a:ext cx="1968454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FXPOI with minimal conditions/ Minimal condition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39774" y="4406602"/>
              <a:ext cx="2377295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solidFill>
                    <a:srgbClr val="FF0000"/>
                  </a:solidFill>
                </a:rPr>
                <a:t>FXPOI with mental health conditions / Mental Health conditions</a:t>
              </a:r>
              <a:endParaRPr 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246201" y="5122539"/>
              <a:ext cx="1164449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XPOI: complex</a:t>
              </a:r>
              <a:endParaRPr 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67914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774620910"/>
              </p:ext>
            </p:extLst>
          </p:nvPr>
        </p:nvGraphicFramePr>
        <p:xfrm>
          <a:off x="2301766" y="1954924"/>
          <a:ext cx="5933090" cy="36865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711559" y="6411310"/>
            <a:ext cx="24804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7052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986" y="125052"/>
            <a:ext cx="5462090" cy="298601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0140" y="125052"/>
            <a:ext cx="5267954" cy="300322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0140" y="3605047"/>
            <a:ext cx="5105832" cy="295756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985" y="3474601"/>
            <a:ext cx="5335967" cy="3088014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5839" y="40972"/>
            <a:ext cx="248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A</a:t>
            </a:r>
            <a:endParaRPr lang="en-US" sz="16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099" y="3451561"/>
            <a:ext cx="248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388295" y="46232"/>
            <a:ext cx="248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388295" y="3451561"/>
            <a:ext cx="248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D</a:t>
            </a:r>
            <a:endParaRPr lang="en-US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732580" y="6377948"/>
            <a:ext cx="2564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0045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68</TotalTime>
  <Words>138</Words>
  <Application>Microsoft Office PowerPoint</Application>
  <PresentationFormat>Widescreen</PresentationFormat>
  <Paragraphs>5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Emo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en, Emily Graves</dc:creator>
  <cp:lastModifiedBy>Allen, Emily Graves</cp:lastModifiedBy>
  <cp:revision>41</cp:revision>
  <dcterms:created xsi:type="dcterms:W3CDTF">2019-08-06T18:12:37Z</dcterms:created>
  <dcterms:modified xsi:type="dcterms:W3CDTF">2019-11-26T14:17:37Z</dcterms:modified>
</cp:coreProperties>
</file>